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71"/>
  </p:normalViewPr>
  <p:slideViewPr>
    <p:cSldViewPr snapToGrid="0">
      <p:cViewPr varScale="1">
        <p:scale>
          <a:sx n="91" d="100"/>
          <a:sy n="91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978943-0F95-47F7-9EAC-3ABDA5037592}" type="datetimeFigureOut">
              <a:rPr lang="en-US" smtClean="0"/>
              <a:t>4/20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D40C7A-7314-4C99-AB65-C8A12B4597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87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D40C7A-7314-4C99-AB65-C8A12B45975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887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29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271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270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62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675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376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883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681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633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802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32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E3740-DEAA-4AE7-AA5C-CC9E1CF5D9B0}" type="datetimeFigureOut">
              <a:rPr lang="en-US" smtClean="0"/>
              <a:t>4/2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2777A0-7A11-48F3-BC6E-CCAC0C6F7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364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54B747E-B7E6-45ED-A99A-97CDCED60C9E}"/>
              </a:ext>
            </a:extLst>
          </p:cNvPr>
          <p:cNvSpPr txBox="1"/>
          <p:nvPr/>
        </p:nvSpPr>
        <p:spPr>
          <a:xfrm>
            <a:off x="405624" y="2525050"/>
            <a:ext cx="1527902" cy="430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APOA-IV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B6CDFA2-74FC-4922-97C3-729BC2D62AC6}"/>
              </a:ext>
            </a:extLst>
          </p:cNvPr>
          <p:cNvSpPr txBox="1"/>
          <p:nvPr/>
        </p:nvSpPr>
        <p:spPr>
          <a:xfrm>
            <a:off x="649826" y="5184844"/>
            <a:ext cx="1306221" cy="430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1BAF9F5A-9752-459A-A803-DD2EB0ABFCFE}"/>
              </a:ext>
            </a:extLst>
          </p:cNvPr>
          <p:cNvGrpSpPr/>
          <p:nvPr/>
        </p:nvGrpSpPr>
        <p:grpSpPr>
          <a:xfrm>
            <a:off x="1709199" y="1021384"/>
            <a:ext cx="3180236" cy="585520"/>
            <a:chOff x="6070963" y="2398402"/>
            <a:chExt cx="3180236" cy="585520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262B47E-AFB8-4F5A-8BD8-D8F358DF5342}"/>
                </a:ext>
              </a:extLst>
            </p:cNvPr>
            <p:cNvSpPr txBox="1"/>
            <p:nvPr/>
          </p:nvSpPr>
          <p:spPr>
            <a:xfrm rot="18934426">
              <a:off x="6070963" y="2398402"/>
              <a:ext cx="14116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Jejunum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FEA65C9-85E1-4894-9E1D-F519288B0613}"/>
                </a:ext>
              </a:extLst>
            </p:cNvPr>
            <p:cNvSpPr txBox="1"/>
            <p:nvPr/>
          </p:nvSpPr>
          <p:spPr>
            <a:xfrm rot="18934426">
              <a:off x="6627786" y="2583812"/>
              <a:ext cx="8818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DDF623F-75E7-4056-B47F-9DF4607DFF06}"/>
                </a:ext>
              </a:extLst>
            </p:cNvPr>
            <p:cNvSpPr txBox="1"/>
            <p:nvPr/>
          </p:nvSpPr>
          <p:spPr>
            <a:xfrm rot="18934426">
              <a:off x="6991659" y="2433909"/>
              <a:ext cx="13101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Adipose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48AA924-B0C0-41D9-A989-C4EB3A877FD8}"/>
                </a:ext>
              </a:extLst>
            </p:cNvPr>
            <p:cNvSpPr txBox="1"/>
            <p:nvPr/>
          </p:nvSpPr>
          <p:spPr>
            <a:xfrm rot="18934426">
              <a:off x="8020954" y="2461889"/>
              <a:ext cx="12302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Plasma 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0846567-B468-4F64-A5EB-E0217B3C9FBA}"/>
                </a:ext>
              </a:extLst>
            </p:cNvPr>
            <p:cNvSpPr txBox="1"/>
            <p:nvPr/>
          </p:nvSpPr>
          <p:spPr>
            <a:xfrm rot="18934426">
              <a:off x="7515096" y="2420487"/>
              <a:ext cx="134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A9AE5C0A-968B-4A24-8A79-432D2BCFB65B}"/>
              </a:ext>
            </a:extLst>
          </p:cNvPr>
          <p:cNvGrpSpPr/>
          <p:nvPr/>
        </p:nvGrpSpPr>
        <p:grpSpPr>
          <a:xfrm>
            <a:off x="4274312" y="1025113"/>
            <a:ext cx="3247471" cy="585520"/>
            <a:chOff x="6070963" y="2398402"/>
            <a:chExt cx="3247471" cy="58552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64186CB-42AA-4AE8-ACC9-30630C955D0E}"/>
                </a:ext>
              </a:extLst>
            </p:cNvPr>
            <p:cNvSpPr txBox="1"/>
            <p:nvPr/>
          </p:nvSpPr>
          <p:spPr>
            <a:xfrm rot="18934426">
              <a:off x="6070963" y="2398402"/>
              <a:ext cx="14116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Jejunum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8FBAEAE-4F1A-4BF2-99BB-E2FA999A244F}"/>
                </a:ext>
              </a:extLst>
            </p:cNvPr>
            <p:cNvSpPr txBox="1"/>
            <p:nvPr/>
          </p:nvSpPr>
          <p:spPr>
            <a:xfrm rot="18934426">
              <a:off x="6695021" y="2583812"/>
              <a:ext cx="8818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7EB2AA3-BF85-4C1A-A082-A2DF27586CD9}"/>
                </a:ext>
              </a:extLst>
            </p:cNvPr>
            <p:cNvSpPr txBox="1"/>
            <p:nvPr/>
          </p:nvSpPr>
          <p:spPr>
            <a:xfrm rot="18934426">
              <a:off x="7058894" y="2433909"/>
              <a:ext cx="13101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Adipose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671C5E2-297C-4FFB-98F9-7ED40979B3A5}"/>
                </a:ext>
              </a:extLst>
            </p:cNvPr>
            <p:cNvSpPr txBox="1"/>
            <p:nvPr/>
          </p:nvSpPr>
          <p:spPr>
            <a:xfrm rot="18934426">
              <a:off x="8088189" y="2461889"/>
              <a:ext cx="12302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Plasma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21B786E-B18F-45BA-98AD-DDC7426C9E18}"/>
                </a:ext>
              </a:extLst>
            </p:cNvPr>
            <p:cNvSpPr txBox="1"/>
            <p:nvPr/>
          </p:nvSpPr>
          <p:spPr>
            <a:xfrm rot="18934426">
              <a:off x="7582331" y="2420487"/>
              <a:ext cx="134853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</a:p>
          </p:txBody>
        </p:sp>
      </p:grp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268B242-580F-4C23-90F2-37F5D9D7FED0}"/>
              </a:ext>
            </a:extLst>
          </p:cNvPr>
          <p:cNvCxnSpPr>
            <a:cxnSpLocks/>
          </p:cNvCxnSpPr>
          <p:nvPr/>
        </p:nvCxnSpPr>
        <p:spPr>
          <a:xfrm>
            <a:off x="2030666" y="6293913"/>
            <a:ext cx="231811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D40EFFC7-7185-4EC8-8E3F-4519926B8DF9}"/>
              </a:ext>
            </a:extLst>
          </p:cNvPr>
          <p:cNvSpPr txBox="1"/>
          <p:nvPr/>
        </p:nvSpPr>
        <p:spPr>
          <a:xfrm>
            <a:off x="2865780" y="6310545"/>
            <a:ext cx="781965" cy="430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DEC236C-58BB-4FF0-8385-6D6C2C0E0EA5}"/>
              </a:ext>
            </a:extLst>
          </p:cNvPr>
          <p:cNvSpPr/>
          <p:nvPr/>
        </p:nvSpPr>
        <p:spPr>
          <a:xfrm>
            <a:off x="4832170" y="6313174"/>
            <a:ext cx="1814590" cy="4282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2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oA</a:t>
            </a:r>
            <a:r>
              <a:rPr lang="en-US" sz="2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IV</a:t>
            </a:r>
            <a:r>
              <a:rPr lang="en-US" sz="22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/-</a:t>
            </a:r>
            <a:endParaRPr lang="en-US" sz="22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87468A3F-F6BE-4357-ABFC-11A0188866AB}"/>
              </a:ext>
            </a:extLst>
          </p:cNvPr>
          <p:cNvCxnSpPr>
            <a:cxnSpLocks/>
          </p:cNvCxnSpPr>
          <p:nvPr/>
        </p:nvCxnSpPr>
        <p:spPr>
          <a:xfrm>
            <a:off x="4469066" y="6293913"/>
            <a:ext cx="25018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0A89E8C4-AFDE-498C-A941-C898380CE7F2}"/>
              </a:ext>
            </a:extLst>
          </p:cNvPr>
          <p:cNvSpPr txBox="1"/>
          <p:nvPr/>
        </p:nvSpPr>
        <p:spPr>
          <a:xfrm>
            <a:off x="0" y="17933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94DB06B-CBD7-4773-B236-550BD4D327C0}"/>
              </a:ext>
            </a:extLst>
          </p:cNvPr>
          <p:cNvCxnSpPr>
            <a:cxnSpLocks/>
          </p:cNvCxnSpPr>
          <p:nvPr/>
        </p:nvCxnSpPr>
        <p:spPr>
          <a:xfrm>
            <a:off x="7199734" y="2717513"/>
            <a:ext cx="11726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2D16106-C943-410B-B9F4-F05731533CC4}"/>
              </a:ext>
            </a:extLst>
          </p:cNvPr>
          <p:cNvCxnSpPr>
            <a:cxnSpLocks/>
          </p:cNvCxnSpPr>
          <p:nvPr/>
        </p:nvCxnSpPr>
        <p:spPr>
          <a:xfrm>
            <a:off x="7199719" y="2885151"/>
            <a:ext cx="11726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8628779-B542-48BF-883B-66BBD32B895E}"/>
              </a:ext>
            </a:extLst>
          </p:cNvPr>
          <p:cNvSpPr txBox="1"/>
          <p:nvPr/>
        </p:nvSpPr>
        <p:spPr>
          <a:xfrm>
            <a:off x="7208801" y="2693611"/>
            <a:ext cx="1098821" cy="430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E660FA8-1CCA-4A73-B1EC-AF04D00C75F2}"/>
              </a:ext>
            </a:extLst>
          </p:cNvPr>
          <p:cNvSpPr txBox="1"/>
          <p:nvPr/>
        </p:nvSpPr>
        <p:spPr>
          <a:xfrm>
            <a:off x="7208804" y="2440526"/>
            <a:ext cx="910468" cy="430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D3582BF9-BC25-45CF-AF25-6DAE2CC5A9BB}"/>
              </a:ext>
            </a:extLst>
          </p:cNvPr>
          <p:cNvGrpSpPr/>
          <p:nvPr/>
        </p:nvGrpSpPr>
        <p:grpSpPr>
          <a:xfrm>
            <a:off x="7206009" y="4969400"/>
            <a:ext cx="1121342" cy="694003"/>
            <a:chOff x="1842449" y="3033024"/>
            <a:chExt cx="1121342" cy="694003"/>
          </a:xfrm>
        </p:grpSpPr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126DB83F-E25E-49D1-BC2B-9A9C827B6EF7}"/>
                </a:ext>
              </a:extLst>
            </p:cNvPr>
            <p:cNvCxnSpPr>
              <a:cxnSpLocks/>
            </p:cNvCxnSpPr>
            <p:nvPr/>
          </p:nvCxnSpPr>
          <p:spPr>
            <a:xfrm>
              <a:off x="1842449" y="3296139"/>
              <a:ext cx="11726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7977DAEF-4BBC-4C4D-AF08-E10B71502B2B}"/>
                </a:ext>
              </a:extLst>
            </p:cNvPr>
            <p:cNvCxnSpPr>
              <a:cxnSpLocks/>
            </p:cNvCxnSpPr>
            <p:nvPr/>
          </p:nvCxnSpPr>
          <p:spPr>
            <a:xfrm>
              <a:off x="1843737" y="3475881"/>
              <a:ext cx="11726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62BE31F-59C6-4529-A984-FA354FEDD1DE}"/>
                </a:ext>
              </a:extLst>
            </p:cNvPr>
            <p:cNvSpPr txBox="1"/>
            <p:nvPr/>
          </p:nvSpPr>
          <p:spPr>
            <a:xfrm>
              <a:off x="1864966" y="3296139"/>
              <a:ext cx="922712" cy="430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4B704D6-4C17-4634-821F-2259822E51E0}"/>
                </a:ext>
              </a:extLst>
            </p:cNvPr>
            <p:cNvSpPr txBox="1"/>
            <p:nvPr/>
          </p:nvSpPr>
          <p:spPr>
            <a:xfrm>
              <a:off x="1864969" y="3033024"/>
              <a:ext cx="1098822" cy="430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CE99AB03-F8C7-4E70-A03B-773C8F3A9B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3526" y="1813790"/>
            <a:ext cx="5255207" cy="212768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3C2E120-A9DF-435B-B3B9-8AAD66137D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3221" y="4011839"/>
            <a:ext cx="5255207" cy="2219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5756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4438CDF-BA58-4176-BF66-B20958E64EA4}"/>
              </a:ext>
            </a:extLst>
          </p:cNvPr>
          <p:cNvSpPr txBox="1"/>
          <p:nvPr/>
        </p:nvSpPr>
        <p:spPr>
          <a:xfrm>
            <a:off x="0" y="17933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03DB85-5199-4610-A9A3-66066843E29F}"/>
              </a:ext>
            </a:extLst>
          </p:cNvPr>
          <p:cNvSpPr txBox="1"/>
          <p:nvPr/>
        </p:nvSpPr>
        <p:spPr>
          <a:xfrm>
            <a:off x="1772812" y="274592"/>
            <a:ext cx="11362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062C28-619F-4727-A086-40BF3012704C}"/>
              </a:ext>
            </a:extLst>
          </p:cNvPr>
          <p:cNvSpPr txBox="1"/>
          <p:nvPr/>
        </p:nvSpPr>
        <p:spPr>
          <a:xfrm rot="18814449">
            <a:off x="1596992" y="1069484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APOA-I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DA455F5-43E6-4B55-8A30-E3A5B5BDB473}"/>
              </a:ext>
            </a:extLst>
          </p:cNvPr>
          <p:cNvSpPr txBox="1"/>
          <p:nvPr/>
        </p:nvSpPr>
        <p:spPr>
          <a:xfrm rot="18814449">
            <a:off x="1968954" y="1077711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P: Goat Ig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D9F8ED-A377-4141-8B5B-4C361A6FA1C2}"/>
              </a:ext>
            </a:extLst>
          </p:cNvPr>
          <p:cNvSpPr txBox="1"/>
          <p:nvPr/>
        </p:nvSpPr>
        <p:spPr>
          <a:xfrm rot="18814449">
            <a:off x="2430658" y="1029198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94B80A7-FFED-4FD5-90CD-BBA238790A8B}"/>
              </a:ext>
            </a:extLst>
          </p:cNvPr>
          <p:cNvSpPr txBox="1"/>
          <p:nvPr/>
        </p:nvSpPr>
        <p:spPr>
          <a:xfrm>
            <a:off x="422716" y="2615343"/>
            <a:ext cx="1136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B: LRP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EC2C01-4E0F-4FBC-B762-6151DD5E4A13}"/>
              </a:ext>
            </a:extLst>
          </p:cNvPr>
          <p:cNvSpPr txBox="1"/>
          <p:nvPr/>
        </p:nvSpPr>
        <p:spPr>
          <a:xfrm>
            <a:off x="133236" y="4976985"/>
            <a:ext cx="15867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B: APOA-IV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43664DE-8C9B-425F-ACCE-51A2A35360F1}"/>
              </a:ext>
            </a:extLst>
          </p:cNvPr>
          <p:cNvSpPr txBox="1"/>
          <p:nvPr/>
        </p:nvSpPr>
        <p:spPr>
          <a:xfrm>
            <a:off x="4395842" y="2703238"/>
            <a:ext cx="1136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B: LRP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2AD337B-5572-4EB5-B5DC-E4BF6D4B495A}"/>
              </a:ext>
            </a:extLst>
          </p:cNvPr>
          <p:cNvSpPr txBox="1"/>
          <p:nvPr/>
        </p:nvSpPr>
        <p:spPr>
          <a:xfrm>
            <a:off x="4124567" y="4882735"/>
            <a:ext cx="15867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B: APOA-IV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58F732-98D5-44D9-9BA4-485DF759F008}"/>
              </a:ext>
            </a:extLst>
          </p:cNvPr>
          <p:cNvSpPr txBox="1"/>
          <p:nvPr/>
        </p:nvSpPr>
        <p:spPr>
          <a:xfrm rot="18814449">
            <a:off x="5890786" y="1077711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APOA-IV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25F72C2-E30D-4705-80CA-85930669AE45}"/>
              </a:ext>
            </a:extLst>
          </p:cNvPr>
          <p:cNvSpPr txBox="1"/>
          <p:nvPr/>
        </p:nvSpPr>
        <p:spPr>
          <a:xfrm rot="18814449">
            <a:off x="6304480" y="1077711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P: Goat Ig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2DA169B-7621-4FBF-BBDD-459F8E5A6918}"/>
              </a:ext>
            </a:extLst>
          </p:cNvPr>
          <p:cNvSpPr txBox="1"/>
          <p:nvPr/>
        </p:nvSpPr>
        <p:spPr>
          <a:xfrm rot="18814449">
            <a:off x="5445154" y="1096230"/>
            <a:ext cx="1581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118EF14-D62E-4162-B6E1-CF0332291020}"/>
              </a:ext>
            </a:extLst>
          </p:cNvPr>
          <p:cNvSpPr txBox="1"/>
          <p:nvPr/>
        </p:nvSpPr>
        <p:spPr>
          <a:xfrm>
            <a:off x="5487134" y="295216"/>
            <a:ext cx="14024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B6CF1EE4-F604-4CDC-A7C4-E9573CE10CC4}"/>
              </a:ext>
            </a:extLst>
          </p:cNvPr>
          <p:cNvCxnSpPr>
            <a:cxnSpLocks/>
          </p:cNvCxnSpPr>
          <p:nvPr/>
        </p:nvCxnSpPr>
        <p:spPr>
          <a:xfrm>
            <a:off x="2980099" y="2898876"/>
            <a:ext cx="846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B434BE6B-6ECE-4A9F-B339-662847F800EE}"/>
              </a:ext>
            </a:extLst>
          </p:cNvPr>
          <p:cNvCxnSpPr>
            <a:cxnSpLocks/>
          </p:cNvCxnSpPr>
          <p:nvPr/>
        </p:nvCxnSpPr>
        <p:spPr>
          <a:xfrm>
            <a:off x="2980099" y="2764245"/>
            <a:ext cx="846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E714297C-3E24-45D8-B36B-0A25F10419A8}"/>
              </a:ext>
            </a:extLst>
          </p:cNvPr>
          <p:cNvSpPr txBox="1"/>
          <p:nvPr/>
        </p:nvSpPr>
        <p:spPr>
          <a:xfrm>
            <a:off x="3006169" y="2777202"/>
            <a:ext cx="479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558CEC3-FC84-49FA-8C1D-3F50852FB35D}"/>
              </a:ext>
            </a:extLst>
          </p:cNvPr>
          <p:cNvSpPr txBox="1"/>
          <p:nvPr/>
        </p:nvSpPr>
        <p:spPr>
          <a:xfrm>
            <a:off x="2991846" y="2596104"/>
            <a:ext cx="652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976ABF89-C631-4CE8-BB0B-8A1800E2FA86}"/>
              </a:ext>
            </a:extLst>
          </p:cNvPr>
          <p:cNvCxnSpPr>
            <a:cxnSpLocks/>
          </p:cNvCxnSpPr>
          <p:nvPr/>
        </p:nvCxnSpPr>
        <p:spPr>
          <a:xfrm>
            <a:off x="2997643" y="5022396"/>
            <a:ext cx="846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C733A031-0511-4FD6-B0B4-FC98A213F682}"/>
              </a:ext>
            </a:extLst>
          </p:cNvPr>
          <p:cNvCxnSpPr>
            <a:cxnSpLocks/>
          </p:cNvCxnSpPr>
          <p:nvPr/>
        </p:nvCxnSpPr>
        <p:spPr>
          <a:xfrm>
            <a:off x="2998572" y="5168372"/>
            <a:ext cx="846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409A0267-8834-4DA2-8DED-BAC954CFF3BF}"/>
              </a:ext>
            </a:extLst>
          </p:cNvPr>
          <p:cNvSpPr txBox="1"/>
          <p:nvPr/>
        </p:nvSpPr>
        <p:spPr>
          <a:xfrm>
            <a:off x="3013896" y="5022396"/>
            <a:ext cx="5670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CFFB9CD-F5E5-4E2B-8270-BF8262D27BF1}"/>
              </a:ext>
            </a:extLst>
          </p:cNvPr>
          <p:cNvSpPr txBox="1"/>
          <p:nvPr/>
        </p:nvSpPr>
        <p:spPr>
          <a:xfrm>
            <a:off x="3013895" y="4858309"/>
            <a:ext cx="567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D1D3BE8D-A21D-4664-9874-15AB72AEC919}"/>
              </a:ext>
            </a:extLst>
          </p:cNvPr>
          <p:cNvCxnSpPr>
            <a:cxnSpLocks/>
          </p:cNvCxnSpPr>
          <p:nvPr/>
        </p:nvCxnSpPr>
        <p:spPr>
          <a:xfrm>
            <a:off x="6841927" y="4962817"/>
            <a:ext cx="846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7990A94-A67F-4409-949D-13FA6E380233}"/>
              </a:ext>
            </a:extLst>
          </p:cNvPr>
          <p:cNvCxnSpPr>
            <a:cxnSpLocks/>
          </p:cNvCxnSpPr>
          <p:nvPr/>
        </p:nvCxnSpPr>
        <p:spPr>
          <a:xfrm>
            <a:off x="6827920" y="5124310"/>
            <a:ext cx="846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A58CF461-8236-4A36-A20D-D5AFB042D6AE}"/>
              </a:ext>
            </a:extLst>
          </p:cNvPr>
          <p:cNvSpPr txBox="1"/>
          <p:nvPr/>
        </p:nvSpPr>
        <p:spPr>
          <a:xfrm>
            <a:off x="6847327" y="4970185"/>
            <a:ext cx="4984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512431F-800D-4822-8B78-540EA0BC7F4B}"/>
              </a:ext>
            </a:extLst>
          </p:cNvPr>
          <p:cNvSpPr txBox="1"/>
          <p:nvPr/>
        </p:nvSpPr>
        <p:spPr>
          <a:xfrm>
            <a:off x="6862263" y="4790581"/>
            <a:ext cx="498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7005760F-328C-48E5-A3C9-28DF5CA57777}"/>
              </a:ext>
            </a:extLst>
          </p:cNvPr>
          <p:cNvGrpSpPr/>
          <p:nvPr/>
        </p:nvGrpSpPr>
        <p:grpSpPr>
          <a:xfrm>
            <a:off x="6837208" y="2624313"/>
            <a:ext cx="743622" cy="488875"/>
            <a:chOff x="6882151" y="2398152"/>
            <a:chExt cx="668884" cy="488875"/>
          </a:xfrm>
        </p:grpSpPr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8E468BCB-0D50-4572-A600-C71BA58915EB}"/>
                </a:ext>
              </a:extLst>
            </p:cNvPr>
            <p:cNvCxnSpPr>
              <a:cxnSpLocks/>
            </p:cNvCxnSpPr>
            <p:nvPr/>
          </p:nvCxnSpPr>
          <p:spPr>
            <a:xfrm>
              <a:off x="6882151" y="2696388"/>
              <a:ext cx="8464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853F9C7E-13AF-41F9-B792-8A06F7282C14}"/>
                </a:ext>
              </a:extLst>
            </p:cNvPr>
            <p:cNvCxnSpPr>
              <a:cxnSpLocks/>
            </p:cNvCxnSpPr>
            <p:nvPr/>
          </p:nvCxnSpPr>
          <p:spPr>
            <a:xfrm>
              <a:off x="6882151" y="2561757"/>
              <a:ext cx="8464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32DB639-7D95-49A9-9570-F528B318D980}"/>
                </a:ext>
              </a:extLst>
            </p:cNvPr>
            <p:cNvSpPr txBox="1"/>
            <p:nvPr/>
          </p:nvSpPr>
          <p:spPr>
            <a:xfrm>
              <a:off x="6913183" y="2579250"/>
              <a:ext cx="4794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A782757-A7E0-4BE1-9F22-482698141291}"/>
                </a:ext>
              </a:extLst>
            </p:cNvPr>
            <p:cNvSpPr txBox="1"/>
            <p:nvPr/>
          </p:nvSpPr>
          <p:spPr>
            <a:xfrm>
              <a:off x="6898860" y="2398152"/>
              <a:ext cx="6521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38CAD6F1-E29E-4039-A003-A4B7A84FAD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1312" y="1837550"/>
            <a:ext cx="1188823" cy="201185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6519F48-9E3C-4F8C-87FC-7B62AAE0AF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8671" y="3929615"/>
            <a:ext cx="1207113" cy="207891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81E8A86-CB1F-47F6-B73D-15AAA14F15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0783" y="1813164"/>
            <a:ext cx="1280271" cy="20362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0A1D7C3-4F6D-419F-B03E-C0E17637A29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29580" y="3926854"/>
            <a:ext cx="1241474" cy="2265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286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80C83D5-F4E0-44D1-A8E8-0655F2227946}"/>
              </a:ext>
            </a:extLst>
          </p:cNvPr>
          <p:cNvSpPr txBox="1"/>
          <p:nvPr/>
        </p:nvSpPr>
        <p:spPr>
          <a:xfrm>
            <a:off x="0" y="17933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3AD6B6-33EE-42A6-9A69-53B593FAF8EF}"/>
              </a:ext>
            </a:extLst>
          </p:cNvPr>
          <p:cNvSpPr txBox="1"/>
          <p:nvPr/>
        </p:nvSpPr>
        <p:spPr>
          <a:xfrm>
            <a:off x="3274962" y="286804"/>
            <a:ext cx="2808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0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7DE149-7AA1-4AB4-ABF0-AC7067FC6968}"/>
              </a:ext>
            </a:extLst>
          </p:cNvPr>
          <p:cNvSpPr txBox="1"/>
          <p:nvPr/>
        </p:nvSpPr>
        <p:spPr>
          <a:xfrm>
            <a:off x="3603039" y="286804"/>
            <a:ext cx="4141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15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186606-B15C-4928-BD29-8CF476D4B1E9}"/>
              </a:ext>
            </a:extLst>
          </p:cNvPr>
          <p:cNvSpPr txBox="1"/>
          <p:nvPr/>
        </p:nvSpPr>
        <p:spPr>
          <a:xfrm>
            <a:off x="4025223" y="286804"/>
            <a:ext cx="446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30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C8B378-704F-4ADA-9466-EAF74696FDFF}"/>
              </a:ext>
            </a:extLst>
          </p:cNvPr>
          <p:cNvSpPr txBox="1"/>
          <p:nvPr/>
        </p:nvSpPr>
        <p:spPr>
          <a:xfrm>
            <a:off x="4439718" y="286804"/>
            <a:ext cx="4141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60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BDCB310-7017-4AA0-8448-5398BB822F0D}"/>
              </a:ext>
            </a:extLst>
          </p:cNvPr>
          <p:cNvSpPr txBox="1"/>
          <p:nvPr/>
        </p:nvSpPr>
        <p:spPr>
          <a:xfrm>
            <a:off x="4835021" y="286804"/>
            <a:ext cx="1157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120  (min)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B2C5C2D-5F8E-4CEB-9101-643676C1716F}"/>
              </a:ext>
            </a:extLst>
          </p:cNvPr>
          <p:cNvSpPr txBox="1"/>
          <p:nvPr/>
        </p:nvSpPr>
        <p:spPr>
          <a:xfrm>
            <a:off x="1686131" y="1317381"/>
            <a:ext cx="15822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B: APOA-IV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5FD3D05-A1EC-485F-A465-F3EF56DCD26B}"/>
              </a:ext>
            </a:extLst>
          </p:cNvPr>
          <p:cNvSpPr txBox="1"/>
          <p:nvPr/>
        </p:nvSpPr>
        <p:spPr>
          <a:xfrm>
            <a:off x="1884824" y="286804"/>
            <a:ext cx="15822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D140860-ABC0-41AD-BAA5-D9293AF85219}"/>
              </a:ext>
            </a:extLst>
          </p:cNvPr>
          <p:cNvGrpSpPr/>
          <p:nvPr/>
        </p:nvGrpSpPr>
        <p:grpSpPr>
          <a:xfrm>
            <a:off x="1106279" y="1942628"/>
            <a:ext cx="5978831" cy="1260236"/>
            <a:chOff x="970470" y="2684085"/>
            <a:chExt cx="5978831" cy="1583478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5BC87A34-BEE2-4CF7-B2A8-D95ABC022A99}"/>
                </a:ext>
              </a:extLst>
            </p:cNvPr>
            <p:cNvGrpSpPr/>
            <p:nvPr/>
          </p:nvGrpSpPr>
          <p:grpSpPr>
            <a:xfrm>
              <a:off x="970470" y="2684085"/>
              <a:ext cx="5978831" cy="1547459"/>
              <a:chOff x="4765368" y="2535519"/>
              <a:chExt cx="5978831" cy="1547459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ED27718-F95C-41E1-A228-67C50A9F6A73}"/>
                  </a:ext>
                </a:extLst>
              </p:cNvPr>
              <p:cNvSpPr txBox="1"/>
              <p:nvPr/>
            </p:nvSpPr>
            <p:spPr>
              <a:xfrm>
                <a:off x="4765368" y="3744424"/>
                <a:ext cx="1582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B: LRP1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87215FC2-B2D9-4FD1-BCD5-493DB860D3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90467" y="2915150"/>
                <a:ext cx="164255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313A0FDE-F596-476A-AC6D-A206E976F8D6}"/>
                  </a:ext>
                </a:extLst>
              </p:cNvPr>
              <p:cNvCxnSpPr/>
              <p:nvPr/>
            </p:nvCxnSpPr>
            <p:spPr>
              <a:xfrm>
                <a:off x="8014131" y="2915150"/>
                <a:ext cx="169030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3DE36D1-E454-40CE-883C-DEA2B2E236F8}"/>
                  </a:ext>
                </a:extLst>
              </p:cNvPr>
              <p:cNvSpPr txBox="1"/>
              <p:nvPr/>
            </p:nvSpPr>
            <p:spPr>
              <a:xfrm>
                <a:off x="6351935" y="2848525"/>
                <a:ext cx="280881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0 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144053B-920F-4EBC-A70C-2D93989D329E}"/>
                  </a:ext>
                </a:extLst>
              </p:cNvPr>
              <p:cNvSpPr txBox="1"/>
              <p:nvPr/>
            </p:nvSpPr>
            <p:spPr>
              <a:xfrm>
                <a:off x="6568465" y="2848525"/>
                <a:ext cx="414139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15 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CC0F8A5-AD9C-4AB6-BD82-F2E132D1DAAA}"/>
                  </a:ext>
                </a:extLst>
              </p:cNvPr>
              <p:cNvSpPr txBox="1"/>
              <p:nvPr/>
            </p:nvSpPr>
            <p:spPr>
              <a:xfrm>
                <a:off x="6907096" y="2848525"/>
                <a:ext cx="446771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30 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2CDA3E9-5181-4059-A110-A7F4D02B12ED}"/>
                  </a:ext>
                </a:extLst>
              </p:cNvPr>
              <p:cNvSpPr txBox="1"/>
              <p:nvPr/>
            </p:nvSpPr>
            <p:spPr>
              <a:xfrm>
                <a:off x="7245725" y="2848525"/>
                <a:ext cx="414139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60 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8C2F14AB-295B-4743-B9F3-D5DEA7255139}"/>
                  </a:ext>
                </a:extLst>
              </p:cNvPr>
              <p:cNvSpPr txBox="1"/>
              <p:nvPr/>
            </p:nvSpPr>
            <p:spPr>
              <a:xfrm>
                <a:off x="7517896" y="2848525"/>
                <a:ext cx="60412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120 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49DE179-55F0-4836-918F-E745E37D3493}"/>
                  </a:ext>
                </a:extLst>
              </p:cNvPr>
              <p:cNvSpPr txBox="1"/>
              <p:nvPr/>
            </p:nvSpPr>
            <p:spPr>
              <a:xfrm>
                <a:off x="8036008" y="2848525"/>
                <a:ext cx="280881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0 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BFACAED9-D15C-446B-8F0B-6FC169B10ED7}"/>
                  </a:ext>
                </a:extLst>
              </p:cNvPr>
              <p:cNvSpPr txBox="1"/>
              <p:nvPr/>
            </p:nvSpPr>
            <p:spPr>
              <a:xfrm>
                <a:off x="8297584" y="2848525"/>
                <a:ext cx="414139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15 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BD41B9F-8C03-4CC8-A3F9-5AF2C5B35DB4}"/>
                  </a:ext>
                </a:extLst>
              </p:cNvPr>
              <p:cNvSpPr txBox="1"/>
              <p:nvPr/>
            </p:nvSpPr>
            <p:spPr>
              <a:xfrm>
                <a:off x="8663242" y="2848525"/>
                <a:ext cx="446771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30 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F4A7CD6-BA13-4A23-B0FE-398786A69665}"/>
                  </a:ext>
                </a:extLst>
              </p:cNvPr>
              <p:cNvSpPr txBox="1"/>
              <p:nvPr/>
            </p:nvSpPr>
            <p:spPr>
              <a:xfrm>
                <a:off x="9010879" y="2848525"/>
                <a:ext cx="414139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60 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5B8C21C-1790-4253-9534-F96268A385A9}"/>
                  </a:ext>
                </a:extLst>
              </p:cNvPr>
              <p:cNvSpPr txBox="1"/>
              <p:nvPr/>
            </p:nvSpPr>
            <p:spPr>
              <a:xfrm>
                <a:off x="9346112" y="2848525"/>
                <a:ext cx="819863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120 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38A2BDA-16A4-4939-976B-70EADC6E8B07}"/>
                  </a:ext>
                </a:extLst>
              </p:cNvPr>
              <p:cNvSpPr txBox="1"/>
              <p:nvPr/>
            </p:nvSpPr>
            <p:spPr>
              <a:xfrm>
                <a:off x="6216054" y="2535519"/>
                <a:ext cx="179041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IP: </a:t>
                </a:r>
                <a:r>
                  <a:rPr lang="el-GR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-APOA-IV 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0625894-AF17-4B08-8CD8-B71B1FAE90F9}"/>
                  </a:ext>
                </a:extLst>
              </p:cNvPr>
              <p:cNvSpPr txBox="1"/>
              <p:nvPr/>
            </p:nvSpPr>
            <p:spPr>
              <a:xfrm>
                <a:off x="7858260" y="2535519"/>
                <a:ext cx="20567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IP: Goat IgG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2CB04D84-DC72-40FA-965B-15B296B1422A}"/>
                  </a:ext>
                </a:extLst>
              </p:cNvPr>
              <p:cNvSpPr txBox="1"/>
              <p:nvPr/>
            </p:nvSpPr>
            <p:spPr>
              <a:xfrm>
                <a:off x="9819159" y="2848525"/>
                <a:ext cx="925040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min)</a:t>
                </a:r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03E4CE61-BF0C-40DA-9BFF-900F53A935F3}"/>
                </a:ext>
              </a:extLst>
            </p:cNvPr>
            <p:cNvGrpSpPr/>
            <p:nvPr/>
          </p:nvGrpSpPr>
          <p:grpSpPr>
            <a:xfrm>
              <a:off x="6018345" y="3778689"/>
              <a:ext cx="673752" cy="488874"/>
              <a:chOff x="3026435" y="2942891"/>
              <a:chExt cx="673752" cy="488874"/>
            </a:xfrm>
          </p:grpSpPr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DC7F674B-375F-4ABA-8096-F0A5E63646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6435" y="3314487"/>
                <a:ext cx="84645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186530D0-5FBB-4175-897C-422A0E017E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6435" y="3091368"/>
                <a:ext cx="84645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FC6C848-926D-4F9A-A1AA-5DCB077C3854}"/>
                  </a:ext>
                </a:extLst>
              </p:cNvPr>
              <p:cNvSpPr txBox="1"/>
              <p:nvPr/>
            </p:nvSpPr>
            <p:spPr>
              <a:xfrm>
                <a:off x="3062335" y="3123989"/>
                <a:ext cx="479409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63BC78E-6AC9-4A95-ABE3-D74CDB628B03}"/>
                  </a:ext>
                </a:extLst>
              </p:cNvPr>
              <p:cNvSpPr txBox="1"/>
              <p:nvPr/>
            </p:nvSpPr>
            <p:spPr>
              <a:xfrm>
                <a:off x="3048012" y="2942891"/>
                <a:ext cx="6521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F1D6A756-7A18-4EE7-B938-DABA106DE768}"/>
              </a:ext>
            </a:extLst>
          </p:cNvPr>
          <p:cNvGrpSpPr/>
          <p:nvPr/>
        </p:nvGrpSpPr>
        <p:grpSpPr>
          <a:xfrm>
            <a:off x="1052515" y="5556326"/>
            <a:ext cx="5756643" cy="412159"/>
            <a:chOff x="913309" y="4970658"/>
            <a:chExt cx="5756643" cy="471864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D965402-0B3D-4305-8AFB-7378C3265C1C}"/>
                </a:ext>
              </a:extLst>
            </p:cNvPr>
            <p:cNvSpPr txBox="1"/>
            <p:nvPr/>
          </p:nvSpPr>
          <p:spPr>
            <a:xfrm>
              <a:off x="913309" y="5069041"/>
              <a:ext cx="158226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B: APOA-IV</a:t>
              </a: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01CC6355-6A67-47ED-B196-FC3A122D694C}"/>
                </a:ext>
              </a:extLst>
            </p:cNvPr>
            <p:cNvGrpSpPr/>
            <p:nvPr/>
          </p:nvGrpSpPr>
          <p:grpSpPr>
            <a:xfrm>
              <a:off x="6007076" y="4970658"/>
              <a:ext cx="662876" cy="471864"/>
              <a:chOff x="3010183" y="4287836"/>
              <a:chExt cx="662876" cy="471864"/>
            </a:xfrm>
          </p:grpSpPr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9CB2A3C3-1F1A-4AF1-856E-44D07FD20E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0183" y="4442091"/>
                <a:ext cx="84645" cy="0"/>
              </a:xfrm>
              <a:prstGeom prst="line">
                <a:avLst/>
              </a:prstGeom>
              <a:ln w="19050">
                <a:noFill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E497F872-442D-4DC7-A5DC-E52B76B887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1112" y="4637227"/>
                <a:ext cx="84645" cy="0"/>
              </a:xfrm>
              <a:prstGeom prst="line">
                <a:avLst/>
              </a:prstGeom>
              <a:ln w="19050">
                <a:noFill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13F30E6-54ED-4046-9D32-D9ABBB8A1FB4}"/>
                  </a:ext>
                </a:extLst>
              </p:cNvPr>
              <p:cNvSpPr txBox="1"/>
              <p:nvPr/>
            </p:nvSpPr>
            <p:spPr>
              <a:xfrm>
                <a:off x="3106039" y="4451923"/>
                <a:ext cx="567020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1E52C1E8-1129-406B-A997-4C81A69A7A3C}"/>
                  </a:ext>
                </a:extLst>
              </p:cNvPr>
              <p:cNvSpPr txBox="1"/>
              <p:nvPr/>
            </p:nvSpPr>
            <p:spPr>
              <a:xfrm>
                <a:off x="3106038" y="4287836"/>
                <a:ext cx="567021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39B328E-7E81-4332-93A7-1FEDECBE8B6F}"/>
              </a:ext>
            </a:extLst>
          </p:cNvPr>
          <p:cNvGrpSpPr/>
          <p:nvPr/>
        </p:nvGrpSpPr>
        <p:grpSpPr>
          <a:xfrm>
            <a:off x="3259891" y="694029"/>
            <a:ext cx="3063004" cy="1281291"/>
            <a:chOff x="3259891" y="218041"/>
            <a:chExt cx="3063004" cy="1281291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93AF125-D761-49C2-991E-52A15A8D0689}"/>
                </a:ext>
              </a:extLst>
            </p:cNvPr>
            <p:cNvSpPr txBox="1"/>
            <p:nvPr/>
          </p:nvSpPr>
          <p:spPr>
            <a:xfrm>
              <a:off x="5583038" y="1008975"/>
              <a:ext cx="739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D6DF704-2C42-4420-9D2B-66E8575BD77B}"/>
                </a:ext>
              </a:extLst>
            </p:cNvPr>
            <p:cNvSpPr txBox="1"/>
            <p:nvPr/>
          </p:nvSpPr>
          <p:spPr>
            <a:xfrm>
              <a:off x="5583038" y="780600"/>
              <a:ext cx="739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BA378BB-9B3A-4B67-87C2-9396D0558707}"/>
                </a:ext>
              </a:extLst>
            </p:cNvPr>
            <p:cNvCxnSpPr>
              <a:cxnSpLocks/>
            </p:cNvCxnSpPr>
            <p:nvPr/>
          </p:nvCxnSpPr>
          <p:spPr>
            <a:xfrm>
              <a:off x="5413557" y="958008"/>
              <a:ext cx="17756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8057C600-B920-48FC-9DA4-215574151C34}"/>
                </a:ext>
              </a:extLst>
            </p:cNvPr>
            <p:cNvCxnSpPr>
              <a:cxnSpLocks/>
            </p:cNvCxnSpPr>
            <p:nvPr/>
          </p:nvCxnSpPr>
          <p:spPr>
            <a:xfrm>
              <a:off x="5413557" y="1150876"/>
              <a:ext cx="17756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70E02475-0335-44E0-A364-D24D2B1F2C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63" t="18429" r="21698" b="56085"/>
            <a:stretch/>
          </p:blipFill>
          <p:spPr>
            <a:xfrm>
              <a:off x="3259891" y="218041"/>
              <a:ext cx="2178401" cy="1281291"/>
            </a:xfrm>
            <a:prstGeom prst="rect">
              <a:avLst/>
            </a:prstGeom>
            <a:ln w="12700">
              <a:noFill/>
            </a:ln>
          </p:spPr>
        </p:pic>
      </p:grp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1CD90259-4E3F-4538-9B58-775FEF5E210F}"/>
              </a:ext>
            </a:extLst>
          </p:cNvPr>
          <p:cNvCxnSpPr>
            <a:cxnSpLocks/>
          </p:cNvCxnSpPr>
          <p:nvPr/>
        </p:nvCxnSpPr>
        <p:spPr>
          <a:xfrm>
            <a:off x="6129627" y="5707450"/>
            <a:ext cx="17756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23B185F-8F4A-404F-A67B-4AB8855A61E7}"/>
              </a:ext>
            </a:extLst>
          </p:cNvPr>
          <p:cNvCxnSpPr>
            <a:cxnSpLocks/>
          </p:cNvCxnSpPr>
          <p:nvPr/>
        </p:nvCxnSpPr>
        <p:spPr>
          <a:xfrm>
            <a:off x="6129627" y="5850214"/>
            <a:ext cx="17756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>
            <a:extLst>
              <a:ext uri="{FF2B5EF4-FFF2-40B4-BE49-F238E27FC236}">
                <a16:creationId xmlns:a16="http://schemas.microsoft.com/office/drawing/2014/main" id="{DC60AD74-9AC1-44C0-826D-0EBB0D9725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2554" y="2537586"/>
            <a:ext cx="3511600" cy="187773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004FE99-F21D-4E81-83FE-8134ED4D62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18027" y="4633610"/>
            <a:ext cx="3511600" cy="19813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7022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4675766-575E-47C4-9723-F2EE394FCB3B}"/>
              </a:ext>
            </a:extLst>
          </p:cNvPr>
          <p:cNvSpPr txBox="1"/>
          <p:nvPr/>
        </p:nvSpPr>
        <p:spPr>
          <a:xfrm>
            <a:off x="0" y="17933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9114753-474C-E446-8653-6FFB8A7A9E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1648" y="2893948"/>
            <a:ext cx="1572904" cy="94496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F86E860-B492-5C47-B76E-EC86551AF4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2499" y="3900814"/>
            <a:ext cx="1475601" cy="512757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C0CD1F02-4BCE-3C4C-96BB-2CF2681180EF}"/>
              </a:ext>
            </a:extLst>
          </p:cNvPr>
          <p:cNvGrpSpPr/>
          <p:nvPr/>
        </p:nvGrpSpPr>
        <p:grpSpPr>
          <a:xfrm>
            <a:off x="2946131" y="1183239"/>
            <a:ext cx="2683353" cy="2603733"/>
            <a:chOff x="5738455" y="4049720"/>
            <a:chExt cx="1957637" cy="2229409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A012DB8-C446-5740-BF40-845994F1160A}"/>
                </a:ext>
              </a:extLst>
            </p:cNvPr>
            <p:cNvSpPr txBox="1"/>
            <p:nvPr/>
          </p:nvSpPr>
          <p:spPr>
            <a:xfrm rot="18343972">
              <a:off x="6382058" y="4675712"/>
              <a:ext cx="1498976" cy="2469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557098D-E993-DF47-AD31-FC90D1C10FA7}"/>
                </a:ext>
              </a:extLst>
            </p:cNvPr>
            <p:cNvSpPr txBox="1"/>
            <p:nvPr/>
          </p:nvSpPr>
          <p:spPr>
            <a:xfrm rot="18343972">
              <a:off x="6887700" y="4718848"/>
              <a:ext cx="1369793" cy="2469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Lrp1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514286B-79E6-2849-81DD-8EC569FA8D27}"/>
                </a:ext>
              </a:extLst>
            </p:cNvPr>
            <p:cNvSpPr txBox="1"/>
            <p:nvPr/>
          </p:nvSpPr>
          <p:spPr>
            <a:xfrm>
              <a:off x="5738455" y="5989247"/>
              <a:ext cx="602708" cy="2898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RP1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F4F7B98B-0C00-284A-AC81-174FE012FE0B}"/>
              </a:ext>
            </a:extLst>
          </p:cNvPr>
          <p:cNvSpPr txBox="1"/>
          <p:nvPr/>
        </p:nvSpPr>
        <p:spPr>
          <a:xfrm>
            <a:off x="2828987" y="4052140"/>
            <a:ext cx="1475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4FF49B62-3C28-934D-943F-791D56C45BB5}"/>
              </a:ext>
            </a:extLst>
          </p:cNvPr>
          <p:cNvCxnSpPr>
            <a:cxnSpLocks/>
          </p:cNvCxnSpPr>
          <p:nvPr/>
        </p:nvCxnSpPr>
        <p:spPr>
          <a:xfrm>
            <a:off x="5334874" y="4218722"/>
            <a:ext cx="1253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B6C7F01-F9A1-A24C-B0CF-5684045CDF54}"/>
              </a:ext>
            </a:extLst>
          </p:cNvPr>
          <p:cNvSpPr txBox="1"/>
          <p:nvPr/>
        </p:nvSpPr>
        <p:spPr>
          <a:xfrm>
            <a:off x="5388126" y="4039394"/>
            <a:ext cx="522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715963E-A95D-3A43-9287-972F226490C5}"/>
              </a:ext>
            </a:extLst>
          </p:cNvPr>
          <p:cNvCxnSpPr>
            <a:cxnSpLocks/>
          </p:cNvCxnSpPr>
          <p:nvPr/>
        </p:nvCxnSpPr>
        <p:spPr>
          <a:xfrm>
            <a:off x="5336381" y="3692165"/>
            <a:ext cx="1034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CEC707C1-960F-734C-903F-8B7B80BE9BBC}"/>
              </a:ext>
            </a:extLst>
          </p:cNvPr>
          <p:cNvSpPr txBox="1"/>
          <p:nvPr/>
        </p:nvSpPr>
        <p:spPr>
          <a:xfrm>
            <a:off x="5394757" y="3552715"/>
            <a:ext cx="522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39E0C5A-554E-0A47-96A6-19814D1C6BF1}"/>
              </a:ext>
            </a:extLst>
          </p:cNvPr>
          <p:cNvCxnSpPr>
            <a:cxnSpLocks/>
          </p:cNvCxnSpPr>
          <p:nvPr/>
        </p:nvCxnSpPr>
        <p:spPr>
          <a:xfrm>
            <a:off x="5331468" y="3569259"/>
            <a:ext cx="1034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27CBFC6-21B3-FA49-947B-C7295790FC23}"/>
              </a:ext>
            </a:extLst>
          </p:cNvPr>
          <p:cNvSpPr txBox="1"/>
          <p:nvPr/>
        </p:nvSpPr>
        <p:spPr>
          <a:xfrm>
            <a:off x="5388126" y="3383435"/>
            <a:ext cx="522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17774642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2CF0F4C-B6D3-4F2C-A50F-ED3DBFC44510}"/>
              </a:ext>
            </a:extLst>
          </p:cNvPr>
          <p:cNvSpPr txBox="1"/>
          <p:nvPr/>
        </p:nvSpPr>
        <p:spPr>
          <a:xfrm>
            <a:off x="129920" y="301392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ABCF5FEB-BC7A-41D3-A604-13D6F865B85C}"/>
              </a:ext>
            </a:extLst>
          </p:cNvPr>
          <p:cNvGrpSpPr/>
          <p:nvPr/>
        </p:nvGrpSpPr>
        <p:grpSpPr>
          <a:xfrm>
            <a:off x="8237126" y="3984371"/>
            <a:ext cx="559865" cy="338554"/>
            <a:chOff x="3295307" y="2333150"/>
            <a:chExt cx="559865" cy="338554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E279A1D0-722D-4039-8D8F-E5A9396ED480}"/>
                </a:ext>
              </a:extLst>
            </p:cNvPr>
            <p:cNvCxnSpPr>
              <a:cxnSpLocks/>
            </p:cNvCxnSpPr>
            <p:nvPr/>
          </p:nvCxnSpPr>
          <p:spPr>
            <a:xfrm>
              <a:off x="3295307" y="2505066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402B2BC-A6C5-49F8-8E44-0A23F5FE6A2B}"/>
                </a:ext>
              </a:extLst>
            </p:cNvPr>
            <p:cNvSpPr txBox="1"/>
            <p:nvPr/>
          </p:nvSpPr>
          <p:spPr>
            <a:xfrm>
              <a:off x="3332931" y="2333150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FA7BA23-ED64-4736-90C7-DFE4EF5E397C}"/>
              </a:ext>
            </a:extLst>
          </p:cNvPr>
          <p:cNvGrpSpPr/>
          <p:nvPr/>
        </p:nvGrpSpPr>
        <p:grpSpPr>
          <a:xfrm>
            <a:off x="8175777" y="1948185"/>
            <a:ext cx="575493" cy="338554"/>
            <a:chOff x="3240147" y="1471316"/>
            <a:chExt cx="575493" cy="338554"/>
          </a:xfrm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8DDF2F46-64F0-4CC8-9898-F854589E2435}"/>
                </a:ext>
              </a:extLst>
            </p:cNvPr>
            <p:cNvCxnSpPr>
              <a:cxnSpLocks/>
            </p:cNvCxnSpPr>
            <p:nvPr/>
          </p:nvCxnSpPr>
          <p:spPr>
            <a:xfrm>
              <a:off x="3240147" y="1650644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D4EEBE6-7A45-47AC-9143-AE864253095B}"/>
                </a:ext>
              </a:extLst>
            </p:cNvPr>
            <p:cNvSpPr txBox="1"/>
            <p:nvPr/>
          </p:nvSpPr>
          <p:spPr>
            <a:xfrm>
              <a:off x="3293399" y="1471316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1EDE7CE3-D9B2-470B-AC29-B4EC63DA2344}"/>
              </a:ext>
            </a:extLst>
          </p:cNvPr>
          <p:cNvSpPr txBox="1"/>
          <p:nvPr/>
        </p:nvSpPr>
        <p:spPr>
          <a:xfrm>
            <a:off x="8089823" y="4334704"/>
            <a:ext cx="9282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B13006AC-4647-44B1-8288-8D49F1FCBA4F}"/>
              </a:ext>
            </a:extLst>
          </p:cNvPr>
          <p:cNvGrpSpPr/>
          <p:nvPr/>
        </p:nvGrpSpPr>
        <p:grpSpPr>
          <a:xfrm>
            <a:off x="8239557" y="2980770"/>
            <a:ext cx="575493" cy="338554"/>
            <a:chOff x="3240147" y="1471316"/>
            <a:chExt cx="575493" cy="338554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F5FC4E5-F7CC-4CE7-B02F-D2FAD6BAEF38}"/>
                </a:ext>
              </a:extLst>
            </p:cNvPr>
            <p:cNvCxnSpPr>
              <a:cxnSpLocks/>
            </p:cNvCxnSpPr>
            <p:nvPr/>
          </p:nvCxnSpPr>
          <p:spPr>
            <a:xfrm>
              <a:off x="3240147" y="1650644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5A6F2B8-9216-4490-B468-3410FE3DD30C}"/>
                </a:ext>
              </a:extLst>
            </p:cNvPr>
            <p:cNvSpPr txBox="1"/>
            <p:nvPr/>
          </p:nvSpPr>
          <p:spPr>
            <a:xfrm>
              <a:off x="3293399" y="1471316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EE3E107-9916-493E-943D-A46E1E85C523}"/>
              </a:ext>
            </a:extLst>
          </p:cNvPr>
          <p:cNvGrpSpPr/>
          <p:nvPr/>
        </p:nvGrpSpPr>
        <p:grpSpPr>
          <a:xfrm>
            <a:off x="1303204" y="1352554"/>
            <a:ext cx="2253961" cy="369332"/>
            <a:chOff x="945421" y="1304007"/>
            <a:chExt cx="2253961" cy="369332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4B1DDF-0D4F-4D7E-9BCF-06AAFF665981}"/>
                </a:ext>
              </a:extLst>
            </p:cNvPr>
            <p:cNvSpPr txBox="1"/>
            <p:nvPr/>
          </p:nvSpPr>
          <p:spPr>
            <a:xfrm>
              <a:off x="945421" y="1304007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A49BD42-B667-4988-8D98-EA38DC584136}"/>
                </a:ext>
              </a:extLst>
            </p:cNvPr>
            <p:cNvSpPr txBox="1"/>
            <p:nvPr/>
          </p:nvSpPr>
          <p:spPr>
            <a:xfrm>
              <a:off x="1783572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01E2541-6800-4733-A7B8-B332EA9D7F91}"/>
                </a:ext>
              </a:extLst>
            </p:cNvPr>
            <p:cNvSpPr txBox="1"/>
            <p:nvPr/>
          </p:nvSpPr>
          <p:spPr>
            <a:xfrm>
              <a:off x="1325297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465CB67-D742-4656-98D4-4D04152667BC}"/>
                </a:ext>
              </a:extLst>
            </p:cNvPr>
            <p:cNvSpPr txBox="1"/>
            <p:nvPr/>
          </p:nvSpPr>
          <p:spPr>
            <a:xfrm>
              <a:off x="2219781" y="1304007"/>
              <a:ext cx="9796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0(min)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7A54B7CF-F7AD-470D-87C0-FBD3BE0D4033}"/>
              </a:ext>
            </a:extLst>
          </p:cNvPr>
          <p:cNvSpPr txBox="1"/>
          <p:nvPr/>
        </p:nvSpPr>
        <p:spPr>
          <a:xfrm>
            <a:off x="493643" y="1858757"/>
            <a:ext cx="9827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CFC647D-B7DE-4D37-9075-69FA03B279B9}"/>
              </a:ext>
            </a:extLst>
          </p:cNvPr>
          <p:cNvSpPr txBox="1"/>
          <p:nvPr/>
        </p:nvSpPr>
        <p:spPr>
          <a:xfrm>
            <a:off x="544421" y="2871535"/>
            <a:ext cx="646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CCD08A6-688A-43B6-A783-A6D669F78A81}"/>
              </a:ext>
            </a:extLst>
          </p:cNvPr>
          <p:cNvSpPr txBox="1"/>
          <p:nvPr/>
        </p:nvSpPr>
        <p:spPr>
          <a:xfrm>
            <a:off x="333554" y="3902007"/>
            <a:ext cx="1533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B3F7FB3D-E5E8-4304-8002-12F6C52FE6AE}"/>
              </a:ext>
            </a:extLst>
          </p:cNvPr>
          <p:cNvGrpSpPr/>
          <p:nvPr/>
        </p:nvGrpSpPr>
        <p:grpSpPr>
          <a:xfrm>
            <a:off x="3772327" y="1352554"/>
            <a:ext cx="2291539" cy="369332"/>
            <a:chOff x="1045629" y="1304007"/>
            <a:chExt cx="2291539" cy="369332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5C8AFFC0-2872-4844-8F48-DF07ABAE5AEB}"/>
                </a:ext>
              </a:extLst>
            </p:cNvPr>
            <p:cNvSpPr txBox="1"/>
            <p:nvPr/>
          </p:nvSpPr>
          <p:spPr>
            <a:xfrm>
              <a:off x="1045629" y="1304007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7330ED8-D840-4D62-8788-0AB34B85D2FA}"/>
                </a:ext>
              </a:extLst>
            </p:cNvPr>
            <p:cNvSpPr txBox="1"/>
            <p:nvPr/>
          </p:nvSpPr>
          <p:spPr>
            <a:xfrm>
              <a:off x="1883780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ECCD8A1-6C70-44DF-AC29-680AF6C93FFE}"/>
                </a:ext>
              </a:extLst>
            </p:cNvPr>
            <p:cNvSpPr txBox="1"/>
            <p:nvPr/>
          </p:nvSpPr>
          <p:spPr>
            <a:xfrm>
              <a:off x="1438031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4A71991-49A8-41EB-A29F-62D99C24C80E}"/>
                </a:ext>
              </a:extLst>
            </p:cNvPr>
            <p:cNvSpPr txBox="1"/>
            <p:nvPr/>
          </p:nvSpPr>
          <p:spPr>
            <a:xfrm>
              <a:off x="2357567" y="1304007"/>
              <a:ext cx="9796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0(min)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1EE9E606-8AFD-4165-B15C-3A86F650756C}"/>
              </a:ext>
            </a:extLst>
          </p:cNvPr>
          <p:cNvGrpSpPr/>
          <p:nvPr/>
        </p:nvGrpSpPr>
        <p:grpSpPr>
          <a:xfrm>
            <a:off x="6253945" y="1369568"/>
            <a:ext cx="2291539" cy="369332"/>
            <a:chOff x="1045629" y="1304007"/>
            <a:chExt cx="2291539" cy="369332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309B942A-6191-4E14-9BE9-588FB9A8D7D3}"/>
                </a:ext>
              </a:extLst>
            </p:cNvPr>
            <p:cNvSpPr txBox="1"/>
            <p:nvPr/>
          </p:nvSpPr>
          <p:spPr>
            <a:xfrm>
              <a:off x="1045629" y="1304007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93CAC95-ECC6-4C9B-A65D-307DD977FE72}"/>
                </a:ext>
              </a:extLst>
            </p:cNvPr>
            <p:cNvSpPr txBox="1"/>
            <p:nvPr/>
          </p:nvSpPr>
          <p:spPr>
            <a:xfrm>
              <a:off x="1883780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5092411-34D8-4BCA-8CD0-56FFFA6B1C37}"/>
                </a:ext>
              </a:extLst>
            </p:cNvPr>
            <p:cNvSpPr txBox="1"/>
            <p:nvPr/>
          </p:nvSpPr>
          <p:spPr>
            <a:xfrm>
              <a:off x="1438031" y="1304007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85173F3-7ECD-4E47-BF71-B33E4F5CAE9B}"/>
                </a:ext>
              </a:extLst>
            </p:cNvPr>
            <p:cNvSpPr txBox="1"/>
            <p:nvPr/>
          </p:nvSpPr>
          <p:spPr>
            <a:xfrm>
              <a:off x="2357567" y="1304007"/>
              <a:ext cx="9796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0(min)</a:t>
              </a:r>
            </a:p>
          </p:txBody>
        </p:sp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28CE0A0B-10DE-4921-BF8D-CDED2A990758}"/>
              </a:ext>
            </a:extLst>
          </p:cNvPr>
          <p:cNvSpPr txBox="1"/>
          <p:nvPr/>
        </p:nvSpPr>
        <p:spPr>
          <a:xfrm>
            <a:off x="1476428" y="4747813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A9D3778-2D36-4D35-B4AA-B16698B102B5}"/>
              </a:ext>
            </a:extLst>
          </p:cNvPr>
          <p:cNvSpPr txBox="1"/>
          <p:nvPr/>
        </p:nvSpPr>
        <p:spPr>
          <a:xfrm>
            <a:off x="3987745" y="4747813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619B34B-8438-4081-8018-6F53EB15E854}"/>
              </a:ext>
            </a:extLst>
          </p:cNvPr>
          <p:cNvSpPr txBox="1"/>
          <p:nvPr/>
        </p:nvSpPr>
        <p:spPr>
          <a:xfrm>
            <a:off x="6539080" y="4747813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3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A99BA3BE-5244-4388-B53D-5769CC3306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1714" y="1748287"/>
            <a:ext cx="1859441" cy="57307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0DEF5911-0362-4EE6-A99B-2196C291D5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8665" y="2795867"/>
            <a:ext cx="1865538" cy="67061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FDCA6FC4-562B-4BE8-A8AD-145AA6787E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8045" y="3711433"/>
            <a:ext cx="1896020" cy="75597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FCACE1B7-686D-4696-8DEB-E503E1B8E1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3204" y="1721886"/>
            <a:ext cx="1774090" cy="676715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9ADD6D5A-9940-4155-B507-830546CC21D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34344" y="2774112"/>
            <a:ext cx="1774090" cy="676715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6787FC43-5670-4F08-A6DA-6A9DD7D1417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16379" y="3790688"/>
            <a:ext cx="1774090" cy="676715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5F35ED94-8791-4EC7-8C52-FD08E4DC0A6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04334" y="1748287"/>
            <a:ext cx="2005758" cy="676715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401EA648-51D1-49E6-980E-A0BF698F78F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89217" y="2774112"/>
            <a:ext cx="2005758" cy="676715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C6021C86-BC74-4BC4-9F31-A5059DB7A03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59663" y="3754108"/>
            <a:ext cx="1896020" cy="7498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6458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671FF9C-6178-4E8E-8479-EE4697D8E18C}"/>
              </a:ext>
            </a:extLst>
          </p:cNvPr>
          <p:cNvSpPr txBox="1"/>
          <p:nvPr/>
        </p:nvSpPr>
        <p:spPr>
          <a:xfrm>
            <a:off x="53971" y="2226723"/>
            <a:ext cx="899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RP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B94A1A9-0766-4328-8AA0-B1013806F8B7}"/>
              </a:ext>
            </a:extLst>
          </p:cNvPr>
          <p:cNvSpPr txBox="1"/>
          <p:nvPr/>
        </p:nvSpPr>
        <p:spPr>
          <a:xfrm>
            <a:off x="-63935" y="4774488"/>
            <a:ext cx="1077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7E99A5-888D-47A5-A428-33EA8169FC15}"/>
              </a:ext>
            </a:extLst>
          </p:cNvPr>
          <p:cNvSpPr txBox="1"/>
          <p:nvPr/>
        </p:nvSpPr>
        <p:spPr>
          <a:xfrm>
            <a:off x="104319" y="3051820"/>
            <a:ext cx="864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89D983-E3F3-49C4-A27E-79ED2EBCC3F3}"/>
              </a:ext>
            </a:extLst>
          </p:cNvPr>
          <p:cNvSpPr txBox="1"/>
          <p:nvPr/>
        </p:nvSpPr>
        <p:spPr>
          <a:xfrm>
            <a:off x="168403" y="3865271"/>
            <a:ext cx="670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B044E655-6A93-4226-9FE0-395F0974673D}"/>
              </a:ext>
            </a:extLst>
          </p:cNvPr>
          <p:cNvGrpSpPr/>
          <p:nvPr/>
        </p:nvGrpSpPr>
        <p:grpSpPr>
          <a:xfrm>
            <a:off x="918779" y="963667"/>
            <a:ext cx="2378525" cy="1037810"/>
            <a:chOff x="918779" y="963667"/>
            <a:chExt cx="2378525" cy="1037810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F153252-027F-4FE0-BD81-970B671EC02E}"/>
                </a:ext>
              </a:extLst>
            </p:cNvPr>
            <p:cNvSpPr txBox="1"/>
            <p:nvPr/>
          </p:nvSpPr>
          <p:spPr>
            <a:xfrm>
              <a:off x="918779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3D8CC55-E522-4F72-88C6-23F72F117C7A}"/>
                </a:ext>
              </a:extLst>
            </p:cNvPr>
            <p:cNvSpPr txBox="1"/>
            <p:nvPr/>
          </p:nvSpPr>
          <p:spPr>
            <a:xfrm>
              <a:off x="1294757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6F3ED86-40C4-454C-AE6A-6A4A2897EA56}"/>
                </a:ext>
              </a:extLst>
            </p:cNvPr>
            <p:cNvSpPr txBox="1"/>
            <p:nvPr/>
          </p:nvSpPr>
          <p:spPr>
            <a:xfrm rot="19356286">
              <a:off x="992481" y="963667"/>
              <a:ext cx="17614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DF71F95-077C-4216-BB62-6F31B7FF9334}"/>
                </a:ext>
              </a:extLst>
            </p:cNvPr>
            <p:cNvSpPr txBox="1"/>
            <p:nvPr/>
          </p:nvSpPr>
          <p:spPr>
            <a:xfrm rot="19400232">
              <a:off x="1847427" y="1034483"/>
              <a:ext cx="144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Lrp1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3F65B70-50E8-4048-BE37-48E9EB6B815C}"/>
                </a:ext>
              </a:extLst>
            </p:cNvPr>
            <p:cNvSpPr txBox="1"/>
            <p:nvPr/>
          </p:nvSpPr>
          <p:spPr>
            <a:xfrm>
              <a:off x="1738015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CA0EE82-E71D-4BAE-910B-BF7816507521}"/>
                </a:ext>
              </a:extLst>
            </p:cNvPr>
            <p:cNvSpPr txBox="1"/>
            <p:nvPr/>
          </p:nvSpPr>
          <p:spPr>
            <a:xfrm>
              <a:off x="2098405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B8520BE-5A00-4BD3-8CEC-F5F2C231A252}"/>
                </a:ext>
              </a:extLst>
            </p:cNvPr>
            <p:cNvCxnSpPr>
              <a:cxnSpLocks/>
            </p:cNvCxnSpPr>
            <p:nvPr/>
          </p:nvCxnSpPr>
          <p:spPr>
            <a:xfrm>
              <a:off x="953504" y="1673345"/>
              <a:ext cx="6947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769B377F-F96A-4476-B9DF-2CEAEC2AFE8F}"/>
                </a:ext>
              </a:extLst>
            </p:cNvPr>
            <p:cNvCxnSpPr>
              <a:cxnSpLocks/>
            </p:cNvCxnSpPr>
            <p:nvPr/>
          </p:nvCxnSpPr>
          <p:spPr>
            <a:xfrm>
              <a:off x="1754898" y="1673345"/>
              <a:ext cx="729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22C1B410-5533-4323-81E5-A595D4C67943}"/>
                </a:ext>
              </a:extLst>
            </p:cNvPr>
            <p:cNvSpPr/>
            <p:nvPr/>
          </p:nvSpPr>
          <p:spPr>
            <a:xfrm>
              <a:off x="2411171" y="1600064"/>
              <a:ext cx="7104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(min)</a:t>
              </a:r>
              <a:endParaRPr lang="en-US" dirty="0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07317E99-D5C2-40DF-9A98-D8CB8693ED39}"/>
              </a:ext>
            </a:extLst>
          </p:cNvPr>
          <p:cNvGrpSpPr/>
          <p:nvPr/>
        </p:nvGrpSpPr>
        <p:grpSpPr>
          <a:xfrm>
            <a:off x="7956030" y="4799924"/>
            <a:ext cx="600385" cy="338554"/>
            <a:chOff x="7161416" y="4705818"/>
            <a:chExt cx="600385" cy="338554"/>
          </a:xfrm>
        </p:grpSpPr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46489876-6DE8-4FAD-B2A4-52F71BCCDDC8}"/>
                </a:ext>
              </a:extLst>
            </p:cNvPr>
            <p:cNvCxnSpPr>
              <a:cxnSpLocks/>
            </p:cNvCxnSpPr>
            <p:nvPr/>
          </p:nvCxnSpPr>
          <p:spPr>
            <a:xfrm>
              <a:off x="7161416" y="4876779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11E726A-DEA3-463E-A38E-977ABE1B7CED}"/>
                </a:ext>
              </a:extLst>
            </p:cNvPr>
            <p:cNvSpPr txBox="1"/>
            <p:nvPr/>
          </p:nvSpPr>
          <p:spPr>
            <a:xfrm>
              <a:off x="7239560" y="4705818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BDBBE4CD-6114-4ABE-9EA5-F0662A1C9D5F}"/>
              </a:ext>
            </a:extLst>
          </p:cNvPr>
          <p:cNvGrpSpPr/>
          <p:nvPr/>
        </p:nvGrpSpPr>
        <p:grpSpPr>
          <a:xfrm>
            <a:off x="7941851" y="2288749"/>
            <a:ext cx="580617" cy="338554"/>
            <a:chOff x="7185485" y="1836396"/>
            <a:chExt cx="580617" cy="338554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28239EE-DE7F-4EDE-B313-245FFB558DBF}"/>
                </a:ext>
              </a:extLst>
            </p:cNvPr>
            <p:cNvCxnSpPr>
              <a:cxnSpLocks/>
            </p:cNvCxnSpPr>
            <p:nvPr/>
          </p:nvCxnSpPr>
          <p:spPr>
            <a:xfrm>
              <a:off x="7185485" y="1975846"/>
              <a:ext cx="1034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B6BA3E0-4D8E-4B49-B24C-79ABD4250B1A}"/>
                </a:ext>
              </a:extLst>
            </p:cNvPr>
            <p:cNvSpPr txBox="1"/>
            <p:nvPr/>
          </p:nvSpPr>
          <p:spPr>
            <a:xfrm>
              <a:off x="7243861" y="1836396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3B4340F4-004C-42A6-B07A-9629711C8B6A}"/>
              </a:ext>
            </a:extLst>
          </p:cNvPr>
          <p:cNvGrpSpPr/>
          <p:nvPr/>
        </p:nvGrpSpPr>
        <p:grpSpPr>
          <a:xfrm>
            <a:off x="7946463" y="2062319"/>
            <a:ext cx="578899" cy="338554"/>
            <a:chOff x="7180572" y="1667116"/>
            <a:chExt cx="578899" cy="338554"/>
          </a:xfrm>
        </p:grpSpPr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0E0ECA5B-F910-4DCE-ADA9-59985192EB7F}"/>
                </a:ext>
              </a:extLst>
            </p:cNvPr>
            <p:cNvCxnSpPr>
              <a:cxnSpLocks/>
            </p:cNvCxnSpPr>
            <p:nvPr/>
          </p:nvCxnSpPr>
          <p:spPr>
            <a:xfrm>
              <a:off x="7180572" y="1852940"/>
              <a:ext cx="1034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E7CBFD3-2600-4688-A337-52AF9CA8467C}"/>
                </a:ext>
              </a:extLst>
            </p:cNvPr>
            <p:cNvSpPr txBox="1"/>
            <p:nvPr/>
          </p:nvSpPr>
          <p:spPr>
            <a:xfrm>
              <a:off x="7237230" y="1667116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F84D782-9EF7-4E5F-AF96-68400868F77D}"/>
              </a:ext>
            </a:extLst>
          </p:cNvPr>
          <p:cNvGrpSpPr/>
          <p:nvPr/>
        </p:nvGrpSpPr>
        <p:grpSpPr>
          <a:xfrm>
            <a:off x="7918879" y="3968466"/>
            <a:ext cx="575493" cy="338554"/>
            <a:chOff x="7195303" y="4071451"/>
            <a:chExt cx="575493" cy="338554"/>
          </a:xfrm>
        </p:grpSpPr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6B38A16-188A-4788-B3A0-3A3651B71C5A}"/>
                </a:ext>
              </a:extLst>
            </p:cNvPr>
            <p:cNvCxnSpPr>
              <a:cxnSpLocks/>
            </p:cNvCxnSpPr>
            <p:nvPr/>
          </p:nvCxnSpPr>
          <p:spPr>
            <a:xfrm>
              <a:off x="7195303" y="4250779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3C20B58-CD16-4481-9189-DB265AAF26F5}"/>
                </a:ext>
              </a:extLst>
            </p:cNvPr>
            <p:cNvSpPr txBox="1"/>
            <p:nvPr/>
          </p:nvSpPr>
          <p:spPr>
            <a:xfrm>
              <a:off x="7248555" y="4071451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74B4299F-CFE5-424C-9F40-F774C0906655}"/>
              </a:ext>
            </a:extLst>
          </p:cNvPr>
          <p:cNvSpPr txBox="1"/>
          <p:nvPr/>
        </p:nvSpPr>
        <p:spPr>
          <a:xfrm>
            <a:off x="7831188" y="5237047"/>
            <a:ext cx="9282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CE04C4D0-2504-480C-AA9C-8CC719A61EB6}"/>
              </a:ext>
            </a:extLst>
          </p:cNvPr>
          <p:cNvGrpSpPr/>
          <p:nvPr/>
        </p:nvGrpSpPr>
        <p:grpSpPr>
          <a:xfrm>
            <a:off x="7946975" y="3054374"/>
            <a:ext cx="575493" cy="338554"/>
            <a:chOff x="3240147" y="1471316"/>
            <a:chExt cx="575493" cy="338554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4728B3F-0FBE-4B3D-9B62-17BA6E29A7A3}"/>
                </a:ext>
              </a:extLst>
            </p:cNvPr>
            <p:cNvCxnSpPr>
              <a:cxnSpLocks/>
            </p:cNvCxnSpPr>
            <p:nvPr/>
          </p:nvCxnSpPr>
          <p:spPr>
            <a:xfrm>
              <a:off x="3240147" y="1650644"/>
              <a:ext cx="1253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94241DE-1116-4870-90F3-F6D0A0A72BFE}"/>
                </a:ext>
              </a:extLst>
            </p:cNvPr>
            <p:cNvSpPr txBox="1"/>
            <p:nvPr/>
          </p:nvSpPr>
          <p:spPr>
            <a:xfrm>
              <a:off x="3293399" y="1471316"/>
              <a:ext cx="5222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1EC5C958-2C55-4FF6-B811-6041C7B25943}"/>
              </a:ext>
            </a:extLst>
          </p:cNvPr>
          <p:cNvSpPr txBox="1"/>
          <p:nvPr/>
        </p:nvSpPr>
        <p:spPr>
          <a:xfrm>
            <a:off x="50352" y="202701"/>
            <a:ext cx="2349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02649947-5D8E-4EC1-89C4-8D25745F9F34}"/>
              </a:ext>
            </a:extLst>
          </p:cNvPr>
          <p:cNvGrpSpPr/>
          <p:nvPr/>
        </p:nvGrpSpPr>
        <p:grpSpPr>
          <a:xfrm>
            <a:off x="3616929" y="950677"/>
            <a:ext cx="2378525" cy="1037810"/>
            <a:chOff x="918779" y="963667"/>
            <a:chExt cx="2378525" cy="1037810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84082D7-FE73-472D-AC2E-70C506CDCCD0}"/>
                </a:ext>
              </a:extLst>
            </p:cNvPr>
            <p:cNvSpPr txBox="1"/>
            <p:nvPr/>
          </p:nvSpPr>
          <p:spPr>
            <a:xfrm>
              <a:off x="918779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2D98C69-9536-4DAC-A090-D343230CE591}"/>
                </a:ext>
              </a:extLst>
            </p:cNvPr>
            <p:cNvSpPr txBox="1"/>
            <p:nvPr/>
          </p:nvSpPr>
          <p:spPr>
            <a:xfrm>
              <a:off x="1294757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380B280-6FE5-40BD-A957-5ADBE2C18324}"/>
                </a:ext>
              </a:extLst>
            </p:cNvPr>
            <p:cNvSpPr txBox="1"/>
            <p:nvPr/>
          </p:nvSpPr>
          <p:spPr>
            <a:xfrm rot="19356286">
              <a:off x="992481" y="963667"/>
              <a:ext cx="17614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0DD9B2B-01E1-4F00-9B25-7E1EC0D97C78}"/>
                </a:ext>
              </a:extLst>
            </p:cNvPr>
            <p:cNvSpPr txBox="1"/>
            <p:nvPr/>
          </p:nvSpPr>
          <p:spPr>
            <a:xfrm rot="19400232">
              <a:off x="1847427" y="1034483"/>
              <a:ext cx="144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Lrp1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93B89CE-A507-49B8-9E3F-ED23ABDD810C}"/>
                </a:ext>
              </a:extLst>
            </p:cNvPr>
            <p:cNvSpPr txBox="1"/>
            <p:nvPr/>
          </p:nvSpPr>
          <p:spPr>
            <a:xfrm>
              <a:off x="1738015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1A24E66-0A52-4DC9-B025-0B81560FD9D6}"/>
                </a:ext>
              </a:extLst>
            </p:cNvPr>
            <p:cNvSpPr txBox="1"/>
            <p:nvPr/>
          </p:nvSpPr>
          <p:spPr>
            <a:xfrm>
              <a:off x="2098405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E6527BD0-E384-438C-852A-01C6EB6AB4DF}"/>
                </a:ext>
              </a:extLst>
            </p:cNvPr>
            <p:cNvCxnSpPr>
              <a:cxnSpLocks/>
            </p:cNvCxnSpPr>
            <p:nvPr/>
          </p:nvCxnSpPr>
          <p:spPr>
            <a:xfrm>
              <a:off x="953504" y="1673345"/>
              <a:ext cx="6947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0FA04B7A-AD12-48F4-A331-53FE4EB68545}"/>
                </a:ext>
              </a:extLst>
            </p:cNvPr>
            <p:cNvCxnSpPr>
              <a:cxnSpLocks/>
            </p:cNvCxnSpPr>
            <p:nvPr/>
          </p:nvCxnSpPr>
          <p:spPr>
            <a:xfrm>
              <a:off x="1754898" y="1673345"/>
              <a:ext cx="729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A6149FF1-0C35-4C99-9CEF-30AEE4E3273C}"/>
                </a:ext>
              </a:extLst>
            </p:cNvPr>
            <p:cNvSpPr/>
            <p:nvPr/>
          </p:nvSpPr>
          <p:spPr>
            <a:xfrm>
              <a:off x="2411171" y="1600064"/>
              <a:ext cx="7104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(min)</a:t>
              </a:r>
              <a:endParaRPr lang="en-US" dirty="0"/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A5C07064-4713-4CAD-8931-D78105D1BE60}"/>
              </a:ext>
            </a:extLst>
          </p:cNvPr>
          <p:cNvGrpSpPr/>
          <p:nvPr/>
        </p:nvGrpSpPr>
        <p:grpSpPr>
          <a:xfrm>
            <a:off x="6100757" y="984863"/>
            <a:ext cx="2378525" cy="1037810"/>
            <a:chOff x="918779" y="963667"/>
            <a:chExt cx="2378525" cy="1037810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5ED29F3-78C5-48F1-A0F9-1E6C219E9072}"/>
                </a:ext>
              </a:extLst>
            </p:cNvPr>
            <p:cNvSpPr txBox="1"/>
            <p:nvPr/>
          </p:nvSpPr>
          <p:spPr>
            <a:xfrm>
              <a:off x="918779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697AC9E-3EF3-4DDC-B027-647A93B7395E}"/>
                </a:ext>
              </a:extLst>
            </p:cNvPr>
            <p:cNvSpPr txBox="1"/>
            <p:nvPr/>
          </p:nvSpPr>
          <p:spPr>
            <a:xfrm>
              <a:off x="1294757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1919381-3D59-4499-A93D-3E307149D984}"/>
                </a:ext>
              </a:extLst>
            </p:cNvPr>
            <p:cNvSpPr txBox="1"/>
            <p:nvPr/>
          </p:nvSpPr>
          <p:spPr>
            <a:xfrm rot="19356286">
              <a:off x="992481" y="963667"/>
              <a:ext cx="17614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B80F3CA-E702-4311-8E5F-DE59140DE2E2}"/>
                </a:ext>
              </a:extLst>
            </p:cNvPr>
            <p:cNvSpPr txBox="1"/>
            <p:nvPr/>
          </p:nvSpPr>
          <p:spPr>
            <a:xfrm rot="19400232">
              <a:off x="1847427" y="1034483"/>
              <a:ext cx="144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Lrp1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67902771-BA64-4C4D-ADCD-7EB2AEC87572}"/>
                </a:ext>
              </a:extLst>
            </p:cNvPr>
            <p:cNvSpPr txBox="1"/>
            <p:nvPr/>
          </p:nvSpPr>
          <p:spPr>
            <a:xfrm>
              <a:off x="1738015" y="1632145"/>
              <a:ext cx="285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BA17592-6CB1-42BA-BEA4-89512D5A2FC9}"/>
                </a:ext>
              </a:extLst>
            </p:cNvPr>
            <p:cNvSpPr txBox="1"/>
            <p:nvPr/>
          </p:nvSpPr>
          <p:spPr>
            <a:xfrm>
              <a:off x="2098405" y="1632145"/>
              <a:ext cx="4473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1104BDE4-18A2-49DE-ACAC-AB89E01531A8}"/>
                </a:ext>
              </a:extLst>
            </p:cNvPr>
            <p:cNvCxnSpPr>
              <a:cxnSpLocks/>
            </p:cNvCxnSpPr>
            <p:nvPr/>
          </p:nvCxnSpPr>
          <p:spPr>
            <a:xfrm>
              <a:off x="953504" y="1673345"/>
              <a:ext cx="6947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321AB508-B0C0-49D4-BE05-362DA1CD8C2B}"/>
                </a:ext>
              </a:extLst>
            </p:cNvPr>
            <p:cNvCxnSpPr>
              <a:cxnSpLocks/>
            </p:cNvCxnSpPr>
            <p:nvPr/>
          </p:nvCxnSpPr>
          <p:spPr>
            <a:xfrm>
              <a:off x="1754898" y="1673345"/>
              <a:ext cx="72933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C3DDE547-8F7B-4317-A849-BEA62B8FD886}"/>
                </a:ext>
              </a:extLst>
            </p:cNvPr>
            <p:cNvSpPr/>
            <p:nvPr/>
          </p:nvSpPr>
          <p:spPr>
            <a:xfrm>
              <a:off x="2411171" y="1600064"/>
              <a:ext cx="7104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(min)</a:t>
              </a:r>
              <a:endParaRPr lang="en-US" dirty="0"/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D8C26256-4740-42C8-A5E8-89DFB9965435}"/>
              </a:ext>
            </a:extLst>
          </p:cNvPr>
          <p:cNvSpPr txBox="1"/>
          <p:nvPr/>
        </p:nvSpPr>
        <p:spPr>
          <a:xfrm>
            <a:off x="970542" y="5375868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B78C2A2-CA6D-4A59-B7CC-007AAC3EA55F}"/>
              </a:ext>
            </a:extLst>
          </p:cNvPr>
          <p:cNvSpPr txBox="1"/>
          <p:nvPr/>
        </p:nvSpPr>
        <p:spPr>
          <a:xfrm>
            <a:off x="3717075" y="5375868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2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8479718-C3E7-4A69-8E04-FC61C54EB63C}"/>
              </a:ext>
            </a:extLst>
          </p:cNvPr>
          <p:cNvSpPr txBox="1"/>
          <p:nvPr/>
        </p:nvSpPr>
        <p:spPr>
          <a:xfrm>
            <a:off x="6236304" y="5375868"/>
            <a:ext cx="136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e 3</a:t>
            </a:r>
          </a:p>
        </p:txBody>
      </p:sp>
      <p:pic>
        <p:nvPicPr>
          <p:cNvPr id="89" name="Picture 88">
            <a:extLst>
              <a:ext uri="{FF2B5EF4-FFF2-40B4-BE49-F238E27FC236}">
                <a16:creationId xmlns:a16="http://schemas.microsoft.com/office/drawing/2014/main" id="{13F3F419-2C27-4B82-B118-F4A651840A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011" y="1928814"/>
            <a:ext cx="1627773" cy="877900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6447C628-116B-4F85-AC1B-1C4B0DF6FD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5248" y="2847138"/>
            <a:ext cx="1627773" cy="737680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FB465573-31B4-4661-9D8A-0EF9EE4B4B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7999" y="3754946"/>
            <a:ext cx="1627773" cy="749873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A7895C9C-FCAC-404C-8FBC-562BCE295B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2865" y="4531048"/>
            <a:ext cx="1627773" cy="890093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ED5EE11E-6779-4AA2-8082-1D04191B6E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53409" y="1939341"/>
            <a:ext cx="1713124" cy="737680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45700E34-9480-41DD-80E2-9CD2FE1E79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67077" y="2897336"/>
            <a:ext cx="1713124" cy="743776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D1713FDC-5FF4-4DFD-8C0E-516E1E6A122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36965" y="3741106"/>
            <a:ext cx="1713124" cy="829128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5FFACA18-6515-4F89-AC16-8C94A7AD26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25965" y="4452448"/>
            <a:ext cx="1713124" cy="969348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A524293E-E0D7-4863-AB4D-E376585BF9C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959757" y="1982297"/>
            <a:ext cx="1767993" cy="73768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4FB7D587-DE80-437D-B248-38ED48D8C1A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955750" y="2874518"/>
            <a:ext cx="1774090" cy="707197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D454360C-0ABE-41DF-A24A-75B87F45259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955750" y="3840638"/>
            <a:ext cx="1761897" cy="640135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A3D72062-6198-4C71-BE2E-178E071B973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40922" y="4628537"/>
            <a:ext cx="1774090" cy="737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4330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6</TotalTime>
  <Words>214</Words>
  <Application>Microsoft Macintosh PowerPoint</Application>
  <PresentationFormat>On-screen Show (4:3)</PresentationFormat>
  <Paragraphs>136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, Jie (quje)</dc:creator>
  <cp:lastModifiedBy>Aditi Bhargava</cp:lastModifiedBy>
  <cp:revision>39</cp:revision>
  <dcterms:created xsi:type="dcterms:W3CDTF">2020-09-29T22:46:18Z</dcterms:created>
  <dcterms:modified xsi:type="dcterms:W3CDTF">2021-04-20T07:35:12Z</dcterms:modified>
</cp:coreProperties>
</file>